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Style moyen 2 - Accentuation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39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7574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3318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5650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1156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0705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8187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0502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5932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9823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2362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9634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3E2FFE-F026-4FCA-A4C1-D0343134F60A}" type="datetimeFigureOut">
              <a:rPr lang="fr-FR" smtClean="0"/>
              <a:t>21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38360-C9C9-4CBC-9698-3E8DE57713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4841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691680" y="1844824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</a:t>
            </a:r>
            <a:endParaRPr lang="fr-FR" sz="1000" dirty="0"/>
          </a:p>
        </p:txBody>
      </p:sp>
      <p:sp>
        <p:nvSpPr>
          <p:cNvPr id="6" name="ZoneTexte 5"/>
          <p:cNvSpPr txBox="1"/>
          <p:nvPr/>
        </p:nvSpPr>
        <p:spPr>
          <a:xfrm>
            <a:off x="611560" y="112474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10" name="ZoneTexte 9"/>
          <p:cNvSpPr txBox="1"/>
          <p:nvPr/>
        </p:nvSpPr>
        <p:spPr>
          <a:xfrm>
            <a:off x="611560" y="357301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  <a:endParaRPr lang="fr-FR" b="1" dirty="0"/>
          </a:p>
        </p:txBody>
      </p:sp>
      <p:graphicFrame>
        <p:nvGraphicFramePr>
          <p:cNvPr id="9" name="Tableau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220648"/>
              </p:ext>
            </p:extLst>
          </p:nvPr>
        </p:nvGraphicFramePr>
        <p:xfrm>
          <a:off x="611560" y="3966230"/>
          <a:ext cx="8064896" cy="170180"/>
        </p:xfrm>
        <a:graphic>
          <a:graphicData uri="http://schemas.openxmlformats.org/drawingml/2006/table">
            <a:tbl>
              <a:tblPr firstRow="1" firstCol="1" bandRow="1"/>
              <a:tblGrid>
                <a:gridCol w="984503"/>
                <a:gridCol w="7080393"/>
              </a:tblGrid>
              <a:tr h="1701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ELD score =</a:t>
                      </a:r>
                      <a:endParaRPr lang="fr-FR" sz="10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 * ((0.480 * </a:t>
                      </a:r>
                      <a:r>
                        <a:rPr lang="en-US" sz="10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ln</a:t>
                      </a: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(Bilirubin)) + (1.857 * </a:t>
                      </a:r>
                      <a:r>
                        <a:rPr lang="en-US" sz="10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ln</a:t>
                      </a: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(INR)) - (0.687 * </a:t>
                      </a:r>
                      <a:r>
                        <a:rPr lang="en-US" sz="10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ln</a:t>
                      </a: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(Albumin)) + </a:t>
                      </a:r>
                      <a:r>
                        <a:rPr lang="en-US" sz="10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ListingAgeFactor</a:t>
                      </a: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 + Growth)</a:t>
                      </a:r>
                      <a:endParaRPr lang="fr-FR" sz="10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7256142"/>
              </p:ext>
            </p:extLst>
          </p:nvPr>
        </p:nvGraphicFramePr>
        <p:xfrm>
          <a:off x="611560" y="1494076"/>
          <a:ext cx="8064897" cy="1882140"/>
        </p:xfrm>
        <a:graphic>
          <a:graphicData uri="http://schemas.openxmlformats.org/drawingml/2006/table">
            <a:tbl>
              <a:tblPr firstRow="1" firstCol="1" bandRow="1"/>
              <a:tblGrid>
                <a:gridCol w="1537334"/>
                <a:gridCol w="1150439"/>
                <a:gridCol w="1344281"/>
                <a:gridCol w="1344281"/>
                <a:gridCol w="1344281"/>
                <a:gridCol w="1344281"/>
              </a:tblGrid>
              <a:tr h="115570">
                <a:tc gridSpan="6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 b="1" dirty="0" err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umber</a:t>
                      </a:r>
                      <a:r>
                        <a:rPr lang="fr-FR" sz="1000" b="1" dirty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 of </a:t>
                      </a:r>
                      <a:r>
                        <a:rPr lang="fr-FR" sz="1000" b="1" dirty="0" err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organ</a:t>
                      </a:r>
                      <a:r>
                        <a:rPr lang="fr-FR" sz="1000" b="1" dirty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fr-FR" sz="1000" b="1" dirty="0" err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ailures</a:t>
                      </a:r>
                      <a:endParaRPr lang="fr-FR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1811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 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0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4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7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spiratory (PaO2/FiO2)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 dirty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&gt;400</a:t>
                      </a:r>
                      <a:endParaRPr lang="fr-FR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&lt;400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&lt;300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&lt;200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&lt;100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</a:tr>
              <a:tr h="17970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eurologic (grade of HE)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o HE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4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368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irculatory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o hypotension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Systolic BP&lt;5th% for age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Dopa&lt;5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Dopa&gt;5 or epi≤0.1 or norepi≤0.1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Dopa&gt;15 or epi&gt;0.1 or norepi&gt;0.1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</a:tr>
              <a:tr h="16446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Hematological (INR)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≤1.1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&gt;1.1 to &lt;1.25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≥1.25 to &lt;1.5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≥1.5 to &lt;2.5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≥2.5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nal (serum creatinine)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ormal for age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&gt;1 to </a:t>
                      </a: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≤2 ULN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&gt;2 to </a:t>
                      </a:r>
                      <a:r>
                        <a:rPr lang="fr-FR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≤3 ULN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&gt;3 ULN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Use of renal remplacement therapy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</a:tr>
              <a:tr h="16637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Liver (serum bilirubin mg/dL)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&lt;1.2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≥1.2 to &lt;2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≥2 to &lt;6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≥6 to &lt;12</a:t>
                      </a:r>
                      <a:endParaRPr lang="fr-FR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≥12</a:t>
                      </a:r>
                      <a:endParaRPr lang="fr-FR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1571741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</TotalTime>
  <Words>164</Words>
  <Application>Microsoft Office PowerPoint</Application>
  <PresentationFormat>Affichage à l'écran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ISSIERES Pierre</dc:creator>
  <cp:lastModifiedBy>TISSIERES Pierre</cp:lastModifiedBy>
  <cp:revision>10</cp:revision>
  <cp:lastPrinted>2019-11-22T15:10:01Z</cp:lastPrinted>
  <dcterms:created xsi:type="dcterms:W3CDTF">2019-08-22T11:51:46Z</dcterms:created>
  <dcterms:modified xsi:type="dcterms:W3CDTF">2020-08-21T15:51:06Z</dcterms:modified>
</cp:coreProperties>
</file>